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9.wmf" ContentType="image/x-wmf"/>
  <Override PartName="/ppt/media/image13.wmf" ContentType="image/x-wmf"/>
  <Override PartName="/ppt/media/image8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11.wmf" ContentType="image/x-wmf"/>
  <Override PartName="/ppt/media/image7.wmf" ContentType="image/x-wmf"/>
  <Override PartName="/ppt/media/image1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73152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B7A962-83F7-40FB-B5D5-2530583DCBC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47560" y="2130120"/>
            <a:ext cx="622008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096920" y="3886200"/>
            <a:ext cx="5121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096920" y="4802040"/>
            <a:ext cx="5121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8E889A-2E58-47D5-BC62-D5343258B9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47560" y="2130120"/>
            <a:ext cx="622008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096920" y="3886200"/>
            <a:ext cx="24991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721320" y="3886200"/>
            <a:ext cx="24991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096920" y="4802040"/>
            <a:ext cx="24991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721320" y="4802040"/>
            <a:ext cx="24991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C93266-F772-4DCF-97A4-430AD541F30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47560" y="2130120"/>
            <a:ext cx="622008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096920" y="3886200"/>
            <a:ext cx="1648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828520" y="3886200"/>
            <a:ext cx="1648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60120" y="3886200"/>
            <a:ext cx="1648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096920" y="4802040"/>
            <a:ext cx="1648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828520" y="4802040"/>
            <a:ext cx="1648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60120" y="4802040"/>
            <a:ext cx="1648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32130D-7E7D-4EB4-A991-FF1B89CD592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959686C-9B54-4CFA-8131-5207015BDD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547560" y="2130120"/>
            <a:ext cx="622008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1096920" y="3886200"/>
            <a:ext cx="5121360" cy="17524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t">
            <a:no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54F12C4-A439-4BDF-9CC2-4ED6CF05C3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547560" y="2130120"/>
            <a:ext cx="622008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1096920" y="3886200"/>
            <a:ext cx="5121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061D2A9-986B-490B-911F-8893AB64E43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547560" y="2130120"/>
            <a:ext cx="622008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1096920" y="3886200"/>
            <a:ext cx="249912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3721320" y="3886200"/>
            <a:ext cx="249912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66B2A4F-CBBE-4D93-B4D4-DFAF11343E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547560" y="2130120"/>
            <a:ext cx="622008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E6E3934-5F56-4BC1-9943-AC2673D5B6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547560" y="2130120"/>
            <a:ext cx="6220080" cy="681480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t">
            <a:noAutofit/>
          </a:bodyPr>
          <a:p>
            <a:pPr algn="ctr">
              <a:spcBef>
                <a:spcPts val="624"/>
              </a:spcBef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0A5D0AB-CF0F-4DDA-92D5-1F2EA44199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547560" y="2130120"/>
            <a:ext cx="622008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1096920" y="3886200"/>
            <a:ext cx="24991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3721320" y="3886200"/>
            <a:ext cx="249912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1096920" y="4802040"/>
            <a:ext cx="24991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51399E0-BE48-47F0-A7B3-B0744EDA5E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47560" y="2130120"/>
            <a:ext cx="622008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096920" y="3886200"/>
            <a:ext cx="5121360" cy="17524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t">
            <a:no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C664F9-0127-4CDF-B2E4-27FED5350B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547560" y="2130120"/>
            <a:ext cx="622008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1096920" y="3886200"/>
            <a:ext cx="249912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3721320" y="3886200"/>
            <a:ext cx="24991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3721320" y="4802040"/>
            <a:ext cx="24991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F6A73E9-B5A0-4AB8-BD02-FB2133D496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547560" y="2130120"/>
            <a:ext cx="622008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1096920" y="3886200"/>
            <a:ext cx="24991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3721320" y="3886200"/>
            <a:ext cx="24991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1096920" y="4802040"/>
            <a:ext cx="5121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E30028B-929E-4C16-BA1D-08FD243C0A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547560" y="2130120"/>
            <a:ext cx="622008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1096920" y="3886200"/>
            <a:ext cx="5121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1096920" y="4802040"/>
            <a:ext cx="5121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9DBE62C-FB31-406A-B87A-BA4B1A5650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547560" y="2130120"/>
            <a:ext cx="622008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1096920" y="3886200"/>
            <a:ext cx="24991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3721320" y="3886200"/>
            <a:ext cx="24991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1096920" y="4802040"/>
            <a:ext cx="24991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3721320" y="4802040"/>
            <a:ext cx="24991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114D165-95DB-4053-8B18-7E820D8E766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547560" y="2130120"/>
            <a:ext cx="622008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1096920" y="3886200"/>
            <a:ext cx="1648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2828520" y="3886200"/>
            <a:ext cx="1648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560120" y="3886200"/>
            <a:ext cx="1648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1096920" y="4802040"/>
            <a:ext cx="1648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2828520" y="4802040"/>
            <a:ext cx="1648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4560120" y="4802040"/>
            <a:ext cx="1648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4A811FC-3981-4E3C-AF5F-31E4FB55F30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47560" y="2130120"/>
            <a:ext cx="622008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096920" y="3886200"/>
            <a:ext cx="5121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08877D-6E07-47AC-9D81-5BE477CD79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47560" y="2130120"/>
            <a:ext cx="622008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096920" y="3886200"/>
            <a:ext cx="249912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721320" y="3886200"/>
            <a:ext cx="249912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AB345C-999B-4CF8-8DAE-B66372A87F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47560" y="2130120"/>
            <a:ext cx="622008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F1A63A-70A4-4A90-9390-6D22FA496C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47560" y="2130120"/>
            <a:ext cx="6220080" cy="681480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t">
            <a:noAutofit/>
          </a:bodyPr>
          <a:p>
            <a:pPr algn="ctr">
              <a:spcBef>
                <a:spcPts val="624"/>
              </a:spcBef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AE71ED-FD47-4DE4-8ABF-6BF7F0367C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47560" y="2130120"/>
            <a:ext cx="622008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096920" y="3886200"/>
            <a:ext cx="24991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721320" y="3886200"/>
            <a:ext cx="249912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096920" y="4802040"/>
            <a:ext cx="24991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106753-3C8A-46E2-8828-56ABDE03D6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47560" y="2130120"/>
            <a:ext cx="622008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096920" y="3886200"/>
            <a:ext cx="249912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721320" y="3886200"/>
            <a:ext cx="24991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721320" y="4802040"/>
            <a:ext cx="24991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23002A-7B36-4C9D-8F9A-0D370FCA2E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47560" y="2130120"/>
            <a:ext cx="622008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096920" y="3886200"/>
            <a:ext cx="24991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721320" y="3886200"/>
            <a:ext cx="24991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096920" y="4802040"/>
            <a:ext cx="5121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9080DC-FBEC-48B4-B931-93E1608A5E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66840" y="274320"/>
            <a:ext cx="6581520" cy="114300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66840" y="1600200"/>
            <a:ext cx="6581520" cy="452592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t">
            <a:normAutofit/>
          </a:bodyPr>
          <a:p>
            <a:pPr marL="272880" indent="-2728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590400" indent="-22680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2" marL="907920" indent="-18072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3" marL="1271520" indent="-18108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4" marL="1635120" indent="-18108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5" marL="1635120" indent="-18108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6" marL="1635120" indent="-18108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66840" y="6244920"/>
            <a:ext cx="1704960" cy="4762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t">
            <a:noAutofit/>
          </a:bodyPr>
          <a:lstStyle>
            <a:lvl1pPr marL="216000" indent="0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  <a:defRPr b="0" lang="en-US" sz="11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500200" y="6244920"/>
            <a:ext cx="2314800" cy="4762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t">
            <a:noAutofit/>
          </a:bodyPr>
          <a:lstStyle>
            <a:lvl1pPr marL="216000"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  <a:defRPr b="0" lang="en-US" sz="11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243400" y="6244920"/>
            <a:ext cx="1704960" cy="4762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t">
            <a:noAutofit/>
          </a:bodyPr>
          <a:lstStyle>
            <a:lvl1pPr marL="216000" indent="0" algn="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  <a:defRPr b="0" lang="en-US" sz="11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fld id="{9CDE5A11-7D4B-41DD-AEAB-170D1118A309}" type="slidenum"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547560" y="2130120"/>
            <a:ext cx="622008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dt" idx="4"/>
          </p:nvPr>
        </p:nvSpPr>
        <p:spPr>
          <a:xfrm>
            <a:off x="366840" y="6244920"/>
            <a:ext cx="1704960" cy="4762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t">
            <a:noAutofit/>
          </a:bodyPr>
          <a:lstStyle>
            <a:lvl1pPr marL="216000" indent="0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  <a:defRPr b="0" lang="en-US" sz="11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ftr" idx="5"/>
          </p:nvPr>
        </p:nvSpPr>
        <p:spPr>
          <a:xfrm>
            <a:off x="2500200" y="6244920"/>
            <a:ext cx="2314800" cy="4762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t">
            <a:noAutofit/>
          </a:bodyPr>
          <a:lstStyle>
            <a:lvl1pPr marL="216000"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  <a:defRPr b="0" lang="en-US" sz="11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sldNum" idx="6"/>
          </p:nvPr>
        </p:nvSpPr>
        <p:spPr>
          <a:xfrm>
            <a:off x="5243400" y="6244920"/>
            <a:ext cx="1704960" cy="4762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t">
            <a:noAutofit/>
          </a:bodyPr>
          <a:lstStyle>
            <a:lvl1pPr marL="216000" indent="0" algn="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  <a:defRPr b="0" lang="en-US" sz="11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fld id="{01BF48BA-CC9E-46BC-B781-5E6D2E76D18E}" type="slidenum"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body"/>
          </p:nvPr>
        </p:nvSpPr>
        <p:spPr>
          <a:xfrm>
            <a:off x="365760" y="1604520"/>
            <a:ext cx="658332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363600" indent="0" algn="ctr">
              <a:spcBef>
                <a:spcPts val="550"/>
              </a:spcBef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2" marL="727200" algn="ctr">
              <a:spcBef>
                <a:spcPts val="476"/>
              </a:spcBef>
              <a:buClr>
                <a:srgbClr val="000000"/>
              </a:buClr>
              <a:buFont typeface="Arial"/>
              <a:buChar char="•"/>
              <a:tabLst>
                <a:tab algn="l" pos="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3" marL="1090440" algn="ctr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1454040" algn="ctr">
              <a:spcBef>
                <a:spcPts val="400"/>
              </a:spcBef>
              <a:buClr>
                <a:srgbClr val="000000"/>
              </a:buClr>
              <a:buFont typeface="Arial"/>
              <a:buChar char="»"/>
              <a:tabLst>
                <a:tab algn="l" pos="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1454040">
              <a:spcBef>
                <a:spcPts val="4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1454040">
              <a:spcBef>
                <a:spcPts val="4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image" Target="../media/image10.wmf"/><Relationship Id="rId11" Type="http://schemas.openxmlformats.org/officeDocument/2006/relationships/image" Target="../media/image11.wmf"/><Relationship Id="rId12" Type="http://schemas.openxmlformats.org/officeDocument/2006/relationships/image" Target="../media/image12.wmf"/><Relationship Id="rId13" Type="http://schemas.openxmlformats.org/officeDocument/2006/relationships/image" Target="../media/image13.wmf"/><Relationship Id="rId14" Type="http://schemas.openxmlformats.org/officeDocument/2006/relationships/image" Target="../media/image14.wmf"/><Relationship Id="rId15" Type="http://schemas.openxmlformats.org/officeDocument/2006/relationships/image" Target="../media/image15.wmf"/><Relationship Id="rId16" Type="http://schemas.openxmlformats.org/officeDocument/2006/relationships/image" Target="../media/image16.wmf"/><Relationship Id="rId17" Type="http://schemas.openxmlformats.org/officeDocument/2006/relationships/slideLayout" Target="../slideLayouts/slideLayout14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" descr=""/>
          <p:cNvPicPr/>
          <p:nvPr/>
        </p:nvPicPr>
        <p:blipFill>
          <a:blip r:embed="rId1"/>
          <a:stretch/>
        </p:blipFill>
        <p:spPr>
          <a:xfrm>
            <a:off x="152280" y="750960"/>
            <a:ext cx="1371600" cy="1307880"/>
          </a:xfrm>
          <a:prstGeom prst="rect">
            <a:avLst/>
          </a:prstGeom>
          <a:ln w="0">
            <a:noFill/>
          </a:ln>
        </p:spPr>
      </p:pic>
      <p:pic>
        <p:nvPicPr>
          <p:cNvPr id="83" name="" descr=""/>
          <p:cNvPicPr/>
          <p:nvPr/>
        </p:nvPicPr>
        <p:blipFill>
          <a:blip r:embed="rId2"/>
          <a:stretch/>
        </p:blipFill>
        <p:spPr>
          <a:xfrm>
            <a:off x="1752480" y="750960"/>
            <a:ext cx="1365480" cy="1301760"/>
          </a:xfrm>
          <a:prstGeom prst="rect">
            <a:avLst/>
          </a:prstGeom>
          <a:ln w="0">
            <a:noFill/>
          </a:ln>
        </p:spPr>
      </p:pic>
      <p:pic>
        <p:nvPicPr>
          <p:cNvPr id="84" name="" descr=""/>
          <p:cNvPicPr/>
          <p:nvPr/>
        </p:nvPicPr>
        <p:blipFill>
          <a:blip r:embed="rId3"/>
          <a:stretch/>
        </p:blipFill>
        <p:spPr>
          <a:xfrm>
            <a:off x="4038480" y="750960"/>
            <a:ext cx="1378080" cy="1314360"/>
          </a:xfrm>
          <a:prstGeom prst="rect">
            <a:avLst/>
          </a:prstGeom>
          <a:ln w="0">
            <a:noFill/>
          </a:ln>
        </p:spPr>
      </p:pic>
      <p:pic>
        <p:nvPicPr>
          <p:cNvPr id="85" name="" descr=""/>
          <p:cNvPicPr/>
          <p:nvPr/>
        </p:nvPicPr>
        <p:blipFill>
          <a:blip r:embed="rId4"/>
          <a:stretch/>
        </p:blipFill>
        <p:spPr>
          <a:xfrm>
            <a:off x="5638680" y="750960"/>
            <a:ext cx="1378080" cy="1314360"/>
          </a:xfrm>
          <a:prstGeom prst="rect">
            <a:avLst/>
          </a:prstGeom>
          <a:ln w="0">
            <a:noFill/>
          </a:ln>
        </p:spPr>
      </p:pic>
      <p:pic>
        <p:nvPicPr>
          <p:cNvPr id="86" name="" descr=""/>
          <p:cNvPicPr/>
          <p:nvPr/>
        </p:nvPicPr>
        <p:blipFill>
          <a:blip r:embed="rId5"/>
          <a:stretch/>
        </p:blipFill>
        <p:spPr>
          <a:xfrm>
            <a:off x="152280" y="2351160"/>
            <a:ext cx="1371600" cy="1307880"/>
          </a:xfrm>
          <a:prstGeom prst="rect">
            <a:avLst/>
          </a:prstGeom>
          <a:ln w="0">
            <a:noFill/>
          </a:ln>
        </p:spPr>
      </p:pic>
      <p:pic>
        <p:nvPicPr>
          <p:cNvPr id="87" name="" descr=""/>
          <p:cNvPicPr/>
          <p:nvPr/>
        </p:nvPicPr>
        <p:blipFill>
          <a:blip r:embed="rId6"/>
          <a:stretch/>
        </p:blipFill>
        <p:spPr>
          <a:xfrm>
            <a:off x="1752480" y="2351160"/>
            <a:ext cx="1371600" cy="1307880"/>
          </a:xfrm>
          <a:prstGeom prst="rect">
            <a:avLst/>
          </a:prstGeom>
          <a:ln w="0">
            <a:noFill/>
          </a:ln>
        </p:spPr>
      </p:pic>
      <p:pic>
        <p:nvPicPr>
          <p:cNvPr id="88" name="" descr=""/>
          <p:cNvPicPr/>
          <p:nvPr/>
        </p:nvPicPr>
        <p:blipFill>
          <a:blip r:embed="rId7"/>
          <a:stretch/>
        </p:blipFill>
        <p:spPr>
          <a:xfrm>
            <a:off x="4038480" y="2351160"/>
            <a:ext cx="1371600" cy="1306440"/>
          </a:xfrm>
          <a:prstGeom prst="rect">
            <a:avLst/>
          </a:prstGeom>
          <a:ln w="0">
            <a:noFill/>
          </a:ln>
        </p:spPr>
      </p:pic>
      <p:pic>
        <p:nvPicPr>
          <p:cNvPr id="89" name="" descr=""/>
          <p:cNvPicPr/>
          <p:nvPr/>
        </p:nvPicPr>
        <p:blipFill>
          <a:blip r:embed="rId8"/>
          <a:stretch/>
        </p:blipFill>
        <p:spPr>
          <a:xfrm>
            <a:off x="5638680" y="2351160"/>
            <a:ext cx="1371600" cy="1307880"/>
          </a:xfrm>
          <a:prstGeom prst="rect">
            <a:avLst/>
          </a:prstGeom>
          <a:ln w="0">
            <a:noFill/>
          </a:ln>
        </p:spPr>
      </p:pic>
      <p:pic>
        <p:nvPicPr>
          <p:cNvPr id="90" name="" descr=""/>
          <p:cNvPicPr/>
          <p:nvPr/>
        </p:nvPicPr>
        <p:blipFill>
          <a:blip r:embed="rId9"/>
          <a:stretch/>
        </p:blipFill>
        <p:spPr>
          <a:xfrm>
            <a:off x="152280" y="3951360"/>
            <a:ext cx="1371600" cy="1306440"/>
          </a:xfrm>
          <a:prstGeom prst="rect">
            <a:avLst/>
          </a:prstGeom>
          <a:ln w="0">
            <a:noFill/>
          </a:ln>
        </p:spPr>
      </p:pic>
      <p:pic>
        <p:nvPicPr>
          <p:cNvPr id="91" name="" descr=""/>
          <p:cNvPicPr/>
          <p:nvPr/>
        </p:nvPicPr>
        <p:blipFill>
          <a:blip r:embed="rId10"/>
          <a:stretch/>
        </p:blipFill>
        <p:spPr>
          <a:xfrm>
            <a:off x="1752480" y="3951360"/>
            <a:ext cx="1371600" cy="1307880"/>
          </a:xfrm>
          <a:prstGeom prst="rect">
            <a:avLst/>
          </a:prstGeom>
          <a:ln w="0">
            <a:noFill/>
          </a:ln>
        </p:spPr>
      </p:pic>
      <p:pic>
        <p:nvPicPr>
          <p:cNvPr id="92" name="" descr=""/>
          <p:cNvPicPr/>
          <p:nvPr/>
        </p:nvPicPr>
        <p:blipFill>
          <a:blip r:embed="rId11"/>
          <a:stretch/>
        </p:blipFill>
        <p:spPr>
          <a:xfrm>
            <a:off x="4038480" y="3951360"/>
            <a:ext cx="1371600" cy="1306440"/>
          </a:xfrm>
          <a:prstGeom prst="rect">
            <a:avLst/>
          </a:prstGeom>
          <a:ln w="0">
            <a:noFill/>
          </a:ln>
        </p:spPr>
      </p:pic>
      <p:pic>
        <p:nvPicPr>
          <p:cNvPr id="93" name="" descr=""/>
          <p:cNvPicPr/>
          <p:nvPr/>
        </p:nvPicPr>
        <p:blipFill>
          <a:blip r:embed="rId12"/>
          <a:stretch/>
        </p:blipFill>
        <p:spPr>
          <a:xfrm>
            <a:off x="5638680" y="3951360"/>
            <a:ext cx="1397160" cy="1333440"/>
          </a:xfrm>
          <a:prstGeom prst="rect">
            <a:avLst/>
          </a:prstGeom>
          <a:ln w="0">
            <a:noFill/>
          </a:ln>
        </p:spPr>
      </p:pic>
      <p:pic>
        <p:nvPicPr>
          <p:cNvPr id="94" name="" descr=""/>
          <p:cNvPicPr/>
          <p:nvPr/>
        </p:nvPicPr>
        <p:blipFill>
          <a:blip r:embed="rId13"/>
          <a:stretch/>
        </p:blipFill>
        <p:spPr>
          <a:xfrm>
            <a:off x="152280" y="5551560"/>
            <a:ext cx="1371600" cy="1306440"/>
          </a:xfrm>
          <a:prstGeom prst="rect">
            <a:avLst/>
          </a:prstGeom>
          <a:ln w="0">
            <a:noFill/>
          </a:ln>
        </p:spPr>
      </p:pic>
      <p:pic>
        <p:nvPicPr>
          <p:cNvPr id="95" name="" descr=""/>
          <p:cNvPicPr/>
          <p:nvPr/>
        </p:nvPicPr>
        <p:blipFill>
          <a:blip r:embed="rId14"/>
          <a:stretch/>
        </p:blipFill>
        <p:spPr>
          <a:xfrm>
            <a:off x="1752480" y="5551560"/>
            <a:ext cx="1371600" cy="1306440"/>
          </a:xfrm>
          <a:prstGeom prst="rect">
            <a:avLst/>
          </a:prstGeom>
          <a:ln w="0">
            <a:noFill/>
          </a:ln>
        </p:spPr>
      </p:pic>
      <p:pic>
        <p:nvPicPr>
          <p:cNvPr id="96" name="" descr=""/>
          <p:cNvPicPr/>
          <p:nvPr/>
        </p:nvPicPr>
        <p:blipFill>
          <a:blip r:embed="rId15"/>
          <a:stretch/>
        </p:blipFill>
        <p:spPr>
          <a:xfrm>
            <a:off x="4038480" y="5551560"/>
            <a:ext cx="1346400" cy="1282680"/>
          </a:xfrm>
          <a:prstGeom prst="rect">
            <a:avLst/>
          </a:prstGeom>
          <a:ln w="0">
            <a:noFill/>
          </a:ln>
        </p:spPr>
      </p:pic>
      <p:pic>
        <p:nvPicPr>
          <p:cNvPr id="97" name="" descr=""/>
          <p:cNvPicPr/>
          <p:nvPr/>
        </p:nvPicPr>
        <p:blipFill>
          <a:blip r:embed="rId16"/>
          <a:stretch/>
        </p:blipFill>
        <p:spPr>
          <a:xfrm>
            <a:off x="5638680" y="5551560"/>
            <a:ext cx="1346400" cy="1282680"/>
          </a:xfrm>
          <a:prstGeom prst="rect">
            <a:avLst/>
          </a:prstGeom>
          <a:ln w="0">
            <a:noFill/>
          </a:ln>
        </p:spPr>
      </p:pic>
      <p:sp>
        <p:nvSpPr>
          <p:cNvPr id="98" name=""/>
          <p:cNvSpPr/>
          <p:nvPr/>
        </p:nvSpPr>
        <p:spPr>
          <a:xfrm>
            <a:off x="462600" y="293040"/>
            <a:ext cx="6261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Genes Ordered Relative to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Plu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 Cells          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Genes Ordered Relative to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Minu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Minu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Plu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Minu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Plu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3278160" y="1024560"/>
            <a:ext cx="547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UU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3354120" y="2426400"/>
            <a:ext cx="54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UU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3354120" y="4148640"/>
            <a:ext cx="509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UD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3354120" y="5825160"/>
            <a:ext cx="5479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UD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5-18T16:11:45Z</dcterms:created>
  <dc:creator>G W Patton</dc:creator>
  <dc:description/>
  <dc:language>en-US</dc:language>
  <cp:lastModifiedBy>G W Patton</cp:lastModifiedBy>
  <dcterms:modified xsi:type="dcterms:W3CDTF">2005-12-23T20:18:35Z</dcterms:modified>
  <cp:revision>7</cp:revision>
  <dc:subject/>
  <dc:title>Slide 1</dc:title>
</cp:coreProperties>
</file>